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89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81A021-3CC2-4247-AD43-F1B3F4BD9CC7}" type="datetimeFigureOut">
              <a:rPr lang="en-US" smtClean="0"/>
              <a:t>3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6A396-64B1-40F3-B848-B3F0EC6E2C34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828800" y="1219200"/>
          <a:ext cx="5181602" cy="2362201"/>
        </p:xfrm>
        <a:graphic>
          <a:graphicData uri="http://schemas.openxmlformats.org/drawingml/2006/table">
            <a:tbl>
              <a:tblPr/>
              <a:tblGrid>
                <a:gridCol w="1431380"/>
                <a:gridCol w="415100"/>
                <a:gridCol w="415100"/>
                <a:gridCol w="415100"/>
                <a:gridCol w="357846"/>
                <a:gridCol w="357846"/>
                <a:gridCol w="357846"/>
                <a:gridCol w="357846"/>
                <a:gridCol w="357846"/>
                <a:gridCol w="357846"/>
                <a:gridCol w="357846"/>
              </a:tblGrid>
              <a:tr h="264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latin typeface="Arial"/>
                        </a:rPr>
                        <a:t>Amino aci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T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E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R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Q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L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A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N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W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G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I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94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latin typeface="Arial"/>
                        </a:rPr>
                        <a:t>Count per amino aci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37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33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3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26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222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216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18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1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137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11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9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latin typeface="Arial"/>
                        </a:rPr>
                        <a:t>Percent of tota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1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1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1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latin typeface="Arial"/>
                        </a:rPr>
                        <a:t>9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8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7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6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5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4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24001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latin typeface="Arial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647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latin typeface="Arial"/>
                        </a:rPr>
                        <a:t>Amino aci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P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V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K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S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H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Y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F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M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C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2945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>
                          <a:latin typeface="Arial"/>
                        </a:rPr>
                        <a:t>Count per amino acid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9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8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8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7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6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54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50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35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28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latin typeface="Arial"/>
                        </a:rPr>
                        <a:t>1</a:t>
                      </a: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491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latin typeface="Arial"/>
                        </a:rPr>
                        <a:t>Percent of total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3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2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1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latin typeface="Arial"/>
                        </a:rPr>
                        <a:t>1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latin typeface="Arial"/>
                        </a:rPr>
                        <a:t>0%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265" name="Rectangle 1"/>
          <p:cNvSpPr>
            <a:spLocks noChangeArrowheads="1"/>
          </p:cNvSpPr>
          <p:nvPr/>
        </p:nvSpPr>
        <p:spPr bwMode="auto">
          <a:xfrm>
            <a:off x="0" y="74711"/>
            <a:ext cx="566161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able 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Frequency of each amino acid found in all </a:t>
            </a:r>
            <a:r>
              <a:rPr kumimoji="0" 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pitope</a:t>
            </a:r>
            <a:r>
              <a:rPr kumimoji="0" 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 definitions</a:t>
            </a:r>
            <a:endParaRPr kumimoji="0" 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0</Words>
  <Application>Microsoft Office PowerPoint</Application>
  <PresentationFormat>On-screen Show 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dim</dc:creator>
  <cp:lastModifiedBy>Nadim</cp:lastModifiedBy>
  <cp:revision>1</cp:revision>
  <dcterms:created xsi:type="dcterms:W3CDTF">2017-03-12T04:50:29Z</dcterms:created>
  <dcterms:modified xsi:type="dcterms:W3CDTF">2017-03-12T04:51:39Z</dcterms:modified>
</cp:coreProperties>
</file>